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9" r:id="rId4"/>
    <p:sldId id="261" r:id="rId5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emf"/><Relationship Id="rId18" Type="http://schemas.openxmlformats.org/officeDocument/2006/relationships/image" Target="../media/image2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17" Type="http://schemas.openxmlformats.org/officeDocument/2006/relationships/image" Target="../media/image23.emf"/><Relationship Id="rId2" Type="http://schemas.openxmlformats.org/officeDocument/2006/relationships/image" Target="../media/image8.emf"/><Relationship Id="rId16" Type="http://schemas.openxmlformats.org/officeDocument/2006/relationships/image" Target="../media/image22.emf"/><Relationship Id="rId1" Type="http://schemas.openxmlformats.org/officeDocument/2006/relationships/image" Target="../media/image7.emf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5" Type="http://schemas.openxmlformats.org/officeDocument/2006/relationships/image" Target="../media/image2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Relationship Id="rId14" Type="http://schemas.openxmlformats.org/officeDocument/2006/relationships/image" Target="../media/image20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13" Type="http://schemas.openxmlformats.org/officeDocument/2006/relationships/image" Target="../media/image39.emf"/><Relationship Id="rId18" Type="http://schemas.openxmlformats.org/officeDocument/2006/relationships/image" Target="../media/image44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12" Type="http://schemas.openxmlformats.org/officeDocument/2006/relationships/image" Target="../media/image38.emf"/><Relationship Id="rId17" Type="http://schemas.openxmlformats.org/officeDocument/2006/relationships/image" Target="../media/image43.emf"/><Relationship Id="rId2" Type="http://schemas.openxmlformats.org/officeDocument/2006/relationships/image" Target="../media/image28.emf"/><Relationship Id="rId16" Type="http://schemas.openxmlformats.org/officeDocument/2006/relationships/image" Target="../media/image42.emf"/><Relationship Id="rId1" Type="http://schemas.openxmlformats.org/officeDocument/2006/relationships/image" Target="../media/image27.emf"/><Relationship Id="rId6" Type="http://schemas.openxmlformats.org/officeDocument/2006/relationships/image" Target="../media/image32.emf"/><Relationship Id="rId11" Type="http://schemas.openxmlformats.org/officeDocument/2006/relationships/image" Target="../media/image37.emf"/><Relationship Id="rId5" Type="http://schemas.openxmlformats.org/officeDocument/2006/relationships/image" Target="../media/image31.emf"/><Relationship Id="rId15" Type="http://schemas.openxmlformats.org/officeDocument/2006/relationships/image" Target="../media/image41.emf"/><Relationship Id="rId10" Type="http://schemas.openxmlformats.org/officeDocument/2006/relationships/image" Target="../media/image36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Relationship Id="rId14" Type="http://schemas.openxmlformats.org/officeDocument/2006/relationships/image" Target="../media/image40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3" Type="http://schemas.openxmlformats.org/officeDocument/2006/relationships/image" Target="../media/image47.emf"/><Relationship Id="rId7" Type="http://schemas.openxmlformats.org/officeDocument/2006/relationships/image" Target="../media/image51.emf"/><Relationship Id="rId2" Type="http://schemas.openxmlformats.org/officeDocument/2006/relationships/image" Target="../media/image46.emf"/><Relationship Id="rId1" Type="http://schemas.openxmlformats.org/officeDocument/2006/relationships/image" Target="../media/image45.emf"/><Relationship Id="rId6" Type="http://schemas.openxmlformats.org/officeDocument/2006/relationships/image" Target="../media/image50.emf"/><Relationship Id="rId5" Type="http://schemas.openxmlformats.org/officeDocument/2006/relationships/image" Target="../media/image49.emf"/><Relationship Id="rId4" Type="http://schemas.openxmlformats.org/officeDocument/2006/relationships/image" Target="../media/image48.emf"/><Relationship Id="rId9" Type="http://schemas.openxmlformats.org/officeDocument/2006/relationships/image" Target="../media/image5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3408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3408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r">
              <a:defRPr sz="1200"/>
            </a:lvl1pPr>
          </a:lstStyle>
          <a:p>
            <a:fld id="{5069BDE4-5279-4361-B24A-419A58860D61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3425" y="1154113"/>
            <a:ext cx="554355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830" tIns="46415" rIns="92830" bIns="4641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44861"/>
            <a:ext cx="5608320" cy="3636705"/>
          </a:xfrm>
          <a:prstGeom prst="rect">
            <a:avLst/>
          </a:prstGeom>
        </p:spPr>
        <p:txBody>
          <a:bodyPr vert="horz" lIns="92830" tIns="46415" rIns="92830" bIns="46415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3407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3407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r">
              <a:defRPr sz="1200"/>
            </a:lvl1pPr>
          </a:lstStyle>
          <a:p>
            <a:fld id="{358ABD6C-99A4-4158-9255-CE8DEC6940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5964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8ABD6C-99A4-4158-9255-CE8DEC6940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922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8ABD6C-99A4-4158-9255-CE8DEC69409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922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8ABD6C-99A4-4158-9255-CE8DEC69409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922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8ABD6C-99A4-4158-9255-CE8DEC69409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922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221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57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057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918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709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37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38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943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867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238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10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A4EA7D-1332-4867-9C6B-DBA346EDE4A9}" type="datetimeFigureOut">
              <a:rPr lang="en-US" smtClean="0"/>
              <a:t>2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6693DF-1999-4DAF-9F53-8EA0B9800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162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0.emf"/><Relationship Id="rId18" Type="http://schemas.openxmlformats.org/officeDocument/2006/relationships/oleObject" Target="../embeddings/oleObject13.bin"/><Relationship Id="rId26" Type="http://schemas.openxmlformats.org/officeDocument/2006/relationships/oleObject" Target="../embeddings/oleObject17.bin"/><Relationship Id="rId39" Type="http://schemas.openxmlformats.org/officeDocument/2006/relationships/image" Target="../media/image23.emf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14.emf"/><Relationship Id="rId34" Type="http://schemas.openxmlformats.org/officeDocument/2006/relationships/oleObject" Target="../embeddings/oleObject21.bin"/><Relationship Id="rId7" Type="http://schemas.openxmlformats.org/officeDocument/2006/relationships/image" Target="../media/image7.emf"/><Relationship Id="rId12" Type="http://schemas.openxmlformats.org/officeDocument/2006/relationships/oleObject" Target="../embeddings/oleObject10.bin"/><Relationship Id="rId17" Type="http://schemas.openxmlformats.org/officeDocument/2006/relationships/image" Target="../media/image12.emf"/><Relationship Id="rId25" Type="http://schemas.openxmlformats.org/officeDocument/2006/relationships/image" Target="../media/image16.emf"/><Relationship Id="rId33" Type="http://schemas.openxmlformats.org/officeDocument/2006/relationships/image" Target="../media/image20.emf"/><Relationship Id="rId38" Type="http://schemas.openxmlformats.org/officeDocument/2006/relationships/oleObject" Target="../embeddings/oleObject23.bin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12.bin"/><Relationship Id="rId20" Type="http://schemas.openxmlformats.org/officeDocument/2006/relationships/oleObject" Target="../embeddings/oleObject14.bin"/><Relationship Id="rId29" Type="http://schemas.openxmlformats.org/officeDocument/2006/relationships/image" Target="../media/image18.emf"/><Relationship Id="rId41" Type="http://schemas.openxmlformats.org/officeDocument/2006/relationships/image" Target="../media/image24.emf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9.emf"/><Relationship Id="rId24" Type="http://schemas.openxmlformats.org/officeDocument/2006/relationships/oleObject" Target="../embeddings/oleObject16.bin"/><Relationship Id="rId32" Type="http://schemas.openxmlformats.org/officeDocument/2006/relationships/oleObject" Target="../embeddings/oleObject20.bin"/><Relationship Id="rId37" Type="http://schemas.openxmlformats.org/officeDocument/2006/relationships/image" Target="../media/image22.emf"/><Relationship Id="rId40" Type="http://schemas.openxmlformats.org/officeDocument/2006/relationships/oleObject" Target="../embeddings/oleObject24.bin"/><Relationship Id="rId5" Type="http://schemas.openxmlformats.org/officeDocument/2006/relationships/image" Target="../media/image26.png"/><Relationship Id="rId15" Type="http://schemas.openxmlformats.org/officeDocument/2006/relationships/image" Target="../media/image11.emf"/><Relationship Id="rId23" Type="http://schemas.openxmlformats.org/officeDocument/2006/relationships/image" Target="../media/image15.emf"/><Relationship Id="rId28" Type="http://schemas.openxmlformats.org/officeDocument/2006/relationships/oleObject" Target="../embeddings/oleObject18.bin"/><Relationship Id="rId36" Type="http://schemas.openxmlformats.org/officeDocument/2006/relationships/oleObject" Target="../embeddings/oleObject22.bin"/><Relationship Id="rId10" Type="http://schemas.openxmlformats.org/officeDocument/2006/relationships/oleObject" Target="../embeddings/oleObject9.bin"/><Relationship Id="rId19" Type="http://schemas.openxmlformats.org/officeDocument/2006/relationships/image" Target="../media/image13.emf"/><Relationship Id="rId31" Type="http://schemas.openxmlformats.org/officeDocument/2006/relationships/image" Target="../media/image19.emf"/><Relationship Id="rId4" Type="http://schemas.openxmlformats.org/officeDocument/2006/relationships/image" Target="../media/image25.emf"/><Relationship Id="rId9" Type="http://schemas.openxmlformats.org/officeDocument/2006/relationships/image" Target="../media/image8.emf"/><Relationship Id="rId14" Type="http://schemas.openxmlformats.org/officeDocument/2006/relationships/oleObject" Target="../embeddings/oleObject11.bin"/><Relationship Id="rId22" Type="http://schemas.openxmlformats.org/officeDocument/2006/relationships/oleObject" Target="../embeddings/oleObject15.bin"/><Relationship Id="rId27" Type="http://schemas.openxmlformats.org/officeDocument/2006/relationships/image" Target="../media/image17.emf"/><Relationship Id="rId30" Type="http://schemas.openxmlformats.org/officeDocument/2006/relationships/oleObject" Target="../embeddings/oleObject19.bin"/><Relationship Id="rId35" Type="http://schemas.openxmlformats.org/officeDocument/2006/relationships/image" Target="../media/image2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6.bin"/><Relationship Id="rId13" Type="http://schemas.openxmlformats.org/officeDocument/2006/relationships/image" Target="../media/image30.emf"/><Relationship Id="rId18" Type="http://schemas.openxmlformats.org/officeDocument/2006/relationships/oleObject" Target="../embeddings/oleObject31.bin"/><Relationship Id="rId26" Type="http://schemas.openxmlformats.org/officeDocument/2006/relationships/oleObject" Target="../embeddings/oleObject35.bin"/><Relationship Id="rId39" Type="http://schemas.openxmlformats.org/officeDocument/2006/relationships/image" Target="../media/image43.emf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34.emf"/><Relationship Id="rId34" Type="http://schemas.openxmlformats.org/officeDocument/2006/relationships/oleObject" Target="../embeddings/oleObject39.bin"/><Relationship Id="rId7" Type="http://schemas.openxmlformats.org/officeDocument/2006/relationships/image" Target="../media/image27.emf"/><Relationship Id="rId12" Type="http://schemas.openxmlformats.org/officeDocument/2006/relationships/oleObject" Target="../embeddings/oleObject28.bin"/><Relationship Id="rId17" Type="http://schemas.openxmlformats.org/officeDocument/2006/relationships/image" Target="../media/image32.emf"/><Relationship Id="rId25" Type="http://schemas.openxmlformats.org/officeDocument/2006/relationships/image" Target="../media/image36.emf"/><Relationship Id="rId33" Type="http://schemas.openxmlformats.org/officeDocument/2006/relationships/image" Target="../media/image40.emf"/><Relationship Id="rId38" Type="http://schemas.openxmlformats.org/officeDocument/2006/relationships/oleObject" Target="../embeddings/oleObject41.bin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30.bin"/><Relationship Id="rId20" Type="http://schemas.openxmlformats.org/officeDocument/2006/relationships/oleObject" Target="../embeddings/oleObject32.bin"/><Relationship Id="rId29" Type="http://schemas.openxmlformats.org/officeDocument/2006/relationships/image" Target="../media/image38.emf"/><Relationship Id="rId41" Type="http://schemas.openxmlformats.org/officeDocument/2006/relationships/image" Target="../media/image44.emf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25.bin"/><Relationship Id="rId11" Type="http://schemas.openxmlformats.org/officeDocument/2006/relationships/image" Target="../media/image29.emf"/><Relationship Id="rId24" Type="http://schemas.openxmlformats.org/officeDocument/2006/relationships/oleObject" Target="../embeddings/oleObject34.bin"/><Relationship Id="rId32" Type="http://schemas.openxmlformats.org/officeDocument/2006/relationships/oleObject" Target="../embeddings/oleObject38.bin"/><Relationship Id="rId37" Type="http://schemas.openxmlformats.org/officeDocument/2006/relationships/image" Target="../media/image42.emf"/><Relationship Id="rId40" Type="http://schemas.openxmlformats.org/officeDocument/2006/relationships/oleObject" Target="../embeddings/oleObject42.bin"/><Relationship Id="rId5" Type="http://schemas.openxmlformats.org/officeDocument/2006/relationships/image" Target="../media/image26.png"/><Relationship Id="rId15" Type="http://schemas.openxmlformats.org/officeDocument/2006/relationships/image" Target="../media/image31.emf"/><Relationship Id="rId23" Type="http://schemas.openxmlformats.org/officeDocument/2006/relationships/image" Target="../media/image35.emf"/><Relationship Id="rId28" Type="http://schemas.openxmlformats.org/officeDocument/2006/relationships/oleObject" Target="../embeddings/oleObject36.bin"/><Relationship Id="rId36" Type="http://schemas.openxmlformats.org/officeDocument/2006/relationships/oleObject" Target="../embeddings/oleObject40.bin"/><Relationship Id="rId10" Type="http://schemas.openxmlformats.org/officeDocument/2006/relationships/oleObject" Target="../embeddings/oleObject27.bin"/><Relationship Id="rId19" Type="http://schemas.openxmlformats.org/officeDocument/2006/relationships/image" Target="../media/image33.emf"/><Relationship Id="rId31" Type="http://schemas.openxmlformats.org/officeDocument/2006/relationships/image" Target="../media/image39.emf"/><Relationship Id="rId4" Type="http://schemas.openxmlformats.org/officeDocument/2006/relationships/image" Target="../media/image25.emf"/><Relationship Id="rId9" Type="http://schemas.openxmlformats.org/officeDocument/2006/relationships/image" Target="../media/image28.emf"/><Relationship Id="rId14" Type="http://schemas.openxmlformats.org/officeDocument/2006/relationships/oleObject" Target="../embeddings/oleObject29.bin"/><Relationship Id="rId22" Type="http://schemas.openxmlformats.org/officeDocument/2006/relationships/oleObject" Target="../embeddings/oleObject33.bin"/><Relationship Id="rId27" Type="http://schemas.openxmlformats.org/officeDocument/2006/relationships/image" Target="../media/image37.emf"/><Relationship Id="rId30" Type="http://schemas.openxmlformats.org/officeDocument/2006/relationships/oleObject" Target="../embeddings/oleObject37.bin"/><Relationship Id="rId35" Type="http://schemas.openxmlformats.org/officeDocument/2006/relationships/image" Target="../media/image4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4.bin"/><Relationship Id="rId13" Type="http://schemas.openxmlformats.org/officeDocument/2006/relationships/image" Target="../media/image48.emf"/><Relationship Id="rId18" Type="http://schemas.openxmlformats.org/officeDocument/2006/relationships/oleObject" Target="../embeddings/oleObject49.bin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52.emf"/><Relationship Id="rId7" Type="http://schemas.openxmlformats.org/officeDocument/2006/relationships/image" Target="../media/image45.emf"/><Relationship Id="rId12" Type="http://schemas.openxmlformats.org/officeDocument/2006/relationships/oleObject" Target="../embeddings/oleObject46.bin"/><Relationship Id="rId17" Type="http://schemas.openxmlformats.org/officeDocument/2006/relationships/image" Target="../media/image50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48.bin"/><Relationship Id="rId20" Type="http://schemas.openxmlformats.org/officeDocument/2006/relationships/oleObject" Target="../embeddings/oleObject50.bin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43.bin"/><Relationship Id="rId11" Type="http://schemas.openxmlformats.org/officeDocument/2006/relationships/image" Target="../media/image47.emf"/><Relationship Id="rId5" Type="http://schemas.openxmlformats.org/officeDocument/2006/relationships/image" Target="../media/image26.png"/><Relationship Id="rId15" Type="http://schemas.openxmlformats.org/officeDocument/2006/relationships/image" Target="../media/image49.emf"/><Relationship Id="rId23" Type="http://schemas.openxmlformats.org/officeDocument/2006/relationships/image" Target="../media/image53.emf"/><Relationship Id="rId10" Type="http://schemas.openxmlformats.org/officeDocument/2006/relationships/oleObject" Target="../embeddings/oleObject45.bin"/><Relationship Id="rId19" Type="http://schemas.openxmlformats.org/officeDocument/2006/relationships/image" Target="../media/image51.emf"/><Relationship Id="rId4" Type="http://schemas.openxmlformats.org/officeDocument/2006/relationships/image" Target="../media/image25.emf"/><Relationship Id="rId9" Type="http://schemas.openxmlformats.org/officeDocument/2006/relationships/image" Target="../media/image46.emf"/><Relationship Id="rId14" Type="http://schemas.openxmlformats.org/officeDocument/2006/relationships/oleObject" Target="../embeddings/oleObject47.bin"/><Relationship Id="rId22" Type="http://schemas.openxmlformats.org/officeDocument/2006/relationships/oleObject" Target="../embeddings/oleObject5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4983486"/>
              </p:ext>
            </p:extLst>
          </p:nvPr>
        </p:nvGraphicFramePr>
        <p:xfrm>
          <a:off x="4108514" y="400368"/>
          <a:ext cx="4048125" cy="276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4" name="Prism 6" r:id="rId4" imgW="4047925" imgH="2762742" progId="Prism6.Document">
                  <p:embed/>
                </p:oleObj>
              </mc:Choice>
              <mc:Fallback>
                <p:oleObj name="Prism 6" r:id="rId4" imgW="4047925" imgH="276274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08514" y="400368"/>
                        <a:ext cx="4048125" cy="276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2622878"/>
              </p:ext>
            </p:extLst>
          </p:nvPr>
        </p:nvGraphicFramePr>
        <p:xfrm>
          <a:off x="7784338" y="382461"/>
          <a:ext cx="3975100" cy="2744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5" name="Prism 6" r:id="rId6" imgW="3974458" imgH="2744374" progId="Prism6.Document">
                  <p:embed/>
                </p:oleObj>
              </mc:Choice>
              <mc:Fallback>
                <p:oleObj name="Prism 6" r:id="rId6" imgW="3974458" imgH="274437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784338" y="382461"/>
                        <a:ext cx="3975100" cy="2744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5450997"/>
              </p:ext>
            </p:extLst>
          </p:nvPr>
        </p:nvGraphicFramePr>
        <p:xfrm>
          <a:off x="446532" y="3134043"/>
          <a:ext cx="4038600" cy="278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6" name="Prism 6" r:id="rId8" imgW="4038562" imgH="2781109" progId="Prism6.Document">
                  <p:embed/>
                </p:oleObj>
              </mc:Choice>
              <mc:Fallback>
                <p:oleObj name="Prism 6" r:id="rId8" imgW="4038562" imgH="278110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46532" y="3134043"/>
                        <a:ext cx="4038600" cy="2781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2494807"/>
              </p:ext>
            </p:extLst>
          </p:nvPr>
        </p:nvGraphicFramePr>
        <p:xfrm>
          <a:off x="4117975" y="3165856"/>
          <a:ext cx="3956050" cy="2790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7" name="Prism 6" r:id="rId10" imgW="3956451" imgH="2790113" progId="Prism6.Document">
                  <p:embed/>
                </p:oleObj>
              </mc:Choice>
              <mc:Fallback>
                <p:oleObj name="Prism 6" r:id="rId10" imgW="3956451" imgH="279011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117975" y="3165856"/>
                        <a:ext cx="3956050" cy="2790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3659930"/>
              </p:ext>
            </p:extLst>
          </p:nvPr>
        </p:nvGraphicFramePr>
        <p:xfrm>
          <a:off x="7783576" y="3139250"/>
          <a:ext cx="4011613" cy="2827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8" name="Prism 6" r:id="rId12" imgW="4011192" imgH="2826849" progId="Prism6.Document">
                  <p:embed/>
                </p:oleObj>
              </mc:Choice>
              <mc:Fallback>
                <p:oleObj name="Prism 6" r:id="rId12" imgW="4011192" imgH="282684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783576" y="3139250"/>
                        <a:ext cx="4011613" cy="2827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9216500"/>
              </p:ext>
            </p:extLst>
          </p:nvPr>
        </p:nvGraphicFramePr>
        <p:xfrm>
          <a:off x="460058" y="386461"/>
          <a:ext cx="4048125" cy="277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9" name="Prism 6" r:id="rId14" imgW="4047925" imgH="2771745" progId="Prism6.Document">
                  <p:embed/>
                </p:oleObj>
              </mc:Choice>
              <mc:Fallback>
                <p:oleObj name="Prism 6" r:id="rId14" imgW="4047925" imgH="277174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60058" y="386461"/>
                        <a:ext cx="4048125" cy="277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5760" y="420624"/>
            <a:ext cx="466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038600" y="426720"/>
            <a:ext cx="466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684008" y="432816"/>
            <a:ext cx="453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2712" y="3160776"/>
            <a:ext cx="466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035552" y="3176016"/>
            <a:ext cx="466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708392" y="3154680"/>
            <a:ext cx="402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702138" y="5920630"/>
            <a:ext cx="10839529" cy="6829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1</a:t>
            </a:r>
            <a:r>
              <a:rPr lang="en-US" sz="12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Circadian patterns of activity and energy expenditure in adult mice.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Wheel running distance in male (a) and female (b) mice; c,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, 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E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nergy expenditure of male (c) and female (d) mice in the presence of a running wheel; e,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f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, Energy expenditure of male (e) and female (f) mice in the absence of a running wheel. Data represent the mean ± SEM of 11-13 mice per experimental group.</a:t>
            </a:r>
            <a:endParaRPr lang="en-US" sz="12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5219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Rectangle 29"/>
          <p:cNvSpPr/>
          <p:nvPr/>
        </p:nvSpPr>
        <p:spPr>
          <a:xfrm>
            <a:off x="333409" y="4459593"/>
            <a:ext cx="4596654" cy="10781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2.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Hepatic </a:t>
            </a:r>
            <a:r>
              <a:rPr lang="en-US" sz="12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expression of genes related to the circadian clock in male mice. 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ata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represent the mean ± SEM of 4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6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 per experimental group and 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ZT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*P&lt;0.05, **P&lt;0.01, ***, P&lt;0.001, as determined by two-way ANOVA and </a:t>
            </a:r>
            <a:r>
              <a:rPr lang="en-US" sz="1200" dirty="0" err="1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Tukey’s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post hoc test. 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4"/>
          <a:srcRect l="66266" t="13656" r="27044" b="78103"/>
          <a:stretch/>
        </p:blipFill>
        <p:spPr>
          <a:xfrm>
            <a:off x="1617608" y="226115"/>
            <a:ext cx="359898" cy="255827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5"/>
          <a:srcRect l="48734" t="-1" r="33222" b="25455"/>
          <a:stretch/>
        </p:blipFill>
        <p:spPr>
          <a:xfrm>
            <a:off x="2696711" y="257348"/>
            <a:ext cx="327804" cy="222689"/>
          </a:xfrm>
          <a:prstGeom prst="rect">
            <a:avLst/>
          </a:prstGeom>
        </p:spPr>
      </p:pic>
      <p:sp>
        <p:nvSpPr>
          <p:cNvPr id="33" name="Rectangle 32"/>
          <p:cNvSpPr/>
          <p:nvPr/>
        </p:nvSpPr>
        <p:spPr>
          <a:xfrm>
            <a:off x="1877301" y="248086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+/+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3008184" y="248086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/-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6368449" y="4469753"/>
            <a:ext cx="4596654" cy="10781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3.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Hepatic </a:t>
            </a:r>
            <a:r>
              <a:rPr lang="en-US" sz="12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expression of genes related to the circadian clock in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female mice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ata represent the mean ± SEM of 4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6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 per experimental group and 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ZT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*P&lt;0.05, **P&lt;0.01, ***, P&lt;0.001, as determined by two-way ANOVA and </a:t>
            </a:r>
            <a:r>
              <a:rPr lang="en-US" sz="1200" dirty="0" err="1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Tukey’s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post hoc test. 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4"/>
          <a:srcRect l="66266" t="13656" r="27044" b="78103"/>
          <a:stretch/>
        </p:blipFill>
        <p:spPr>
          <a:xfrm>
            <a:off x="7652648" y="236275"/>
            <a:ext cx="359898" cy="255827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/>
          <a:srcRect l="48734" t="-1" r="33222" b="25455"/>
          <a:stretch/>
        </p:blipFill>
        <p:spPr>
          <a:xfrm>
            <a:off x="8731751" y="267508"/>
            <a:ext cx="327804" cy="222689"/>
          </a:xfrm>
          <a:prstGeom prst="rect">
            <a:avLst/>
          </a:prstGeom>
        </p:spPr>
      </p:pic>
      <p:sp>
        <p:nvSpPr>
          <p:cNvPr id="42" name="Rectangle 41"/>
          <p:cNvSpPr/>
          <p:nvPr/>
        </p:nvSpPr>
        <p:spPr>
          <a:xfrm>
            <a:off x="7912341" y="258246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+/+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9043224" y="258246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/-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7763673"/>
              </p:ext>
            </p:extLst>
          </p:nvPr>
        </p:nvGraphicFramePr>
        <p:xfrm>
          <a:off x="312225" y="460888"/>
          <a:ext cx="176418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1" name="Prism 6" r:id="rId6" imgW="4015873" imgH="3122536" progId="Prism6.Document">
                  <p:embed/>
                </p:oleObj>
              </mc:Choice>
              <mc:Fallback>
                <p:oleObj name="Prism 6" r:id="rId6" imgW="4015873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2225" y="460888"/>
                        <a:ext cx="176418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3839824"/>
              </p:ext>
            </p:extLst>
          </p:nvPr>
        </p:nvGraphicFramePr>
        <p:xfrm>
          <a:off x="1814001" y="451056"/>
          <a:ext cx="1783707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2" name="Prism 6" r:id="rId8" imgW="4061611" imgH="3122536" progId="Prism6.Document">
                  <p:embed/>
                </p:oleObj>
              </mc:Choice>
              <mc:Fallback>
                <p:oleObj name="Prism 6" r:id="rId8" imgW="4061611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814001" y="451056"/>
                        <a:ext cx="1783707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412874"/>
              </p:ext>
            </p:extLst>
          </p:nvPr>
        </p:nvGraphicFramePr>
        <p:xfrm>
          <a:off x="3350394" y="451055"/>
          <a:ext cx="176418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3" name="Prism 6" r:id="rId10" imgW="4015873" imgH="3122536" progId="Prism6.Document">
                  <p:embed/>
                </p:oleObj>
              </mc:Choice>
              <mc:Fallback>
                <p:oleObj name="Prism 6" r:id="rId10" imgW="4015873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350394" y="451055"/>
                        <a:ext cx="176418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4404777"/>
              </p:ext>
            </p:extLst>
          </p:nvPr>
        </p:nvGraphicFramePr>
        <p:xfrm>
          <a:off x="312227" y="1778409"/>
          <a:ext cx="176418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4" name="Prism 6" r:id="rId12" imgW="4015873" imgH="3122536" progId="Prism6.Document">
                  <p:embed/>
                </p:oleObj>
              </mc:Choice>
              <mc:Fallback>
                <p:oleObj name="Prism 6" r:id="rId12" imgW="4015873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12227" y="1778409"/>
                        <a:ext cx="176418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2904745"/>
              </p:ext>
            </p:extLst>
          </p:nvPr>
        </p:nvGraphicFramePr>
        <p:xfrm>
          <a:off x="1816562" y="1788600"/>
          <a:ext cx="176418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5" name="Prism 6" r:id="rId14" imgW="4015873" imgH="3122536" progId="Prism6.Document">
                  <p:embed/>
                </p:oleObj>
              </mc:Choice>
              <mc:Fallback>
                <p:oleObj name="Prism 6" r:id="rId14" imgW="4015873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816562" y="1788600"/>
                        <a:ext cx="176418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8709141"/>
              </p:ext>
            </p:extLst>
          </p:nvPr>
        </p:nvGraphicFramePr>
        <p:xfrm>
          <a:off x="3330423" y="1788240"/>
          <a:ext cx="175581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6" name="Prism 6" r:id="rId16" imgW="3997506" imgH="3122536" progId="Prism6.Document">
                  <p:embed/>
                </p:oleObj>
              </mc:Choice>
              <mc:Fallback>
                <p:oleObj name="Prism 6" r:id="rId16" imgW="3997506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330423" y="1788240"/>
                        <a:ext cx="175581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9626696"/>
              </p:ext>
            </p:extLst>
          </p:nvPr>
        </p:nvGraphicFramePr>
        <p:xfrm>
          <a:off x="3274859" y="3086100"/>
          <a:ext cx="180392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7" name="Prism 6" r:id="rId18" imgW="4107348" imgH="3122536" progId="Prism6.Document">
                  <p:embed/>
                </p:oleObj>
              </mc:Choice>
              <mc:Fallback>
                <p:oleObj name="Prism 6" r:id="rId18" imgW="4107348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274859" y="3086100"/>
                        <a:ext cx="180392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8449072"/>
              </p:ext>
            </p:extLst>
          </p:nvPr>
        </p:nvGraphicFramePr>
        <p:xfrm>
          <a:off x="270950" y="3086098"/>
          <a:ext cx="179974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8" name="Prism 6" r:id="rId20" imgW="4097984" imgH="3122536" progId="Prism6.Document">
                  <p:embed/>
                </p:oleObj>
              </mc:Choice>
              <mc:Fallback>
                <p:oleObj name="Prism 6" r:id="rId20" imgW="4097984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270950" y="3086098"/>
                        <a:ext cx="179974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8993558"/>
              </p:ext>
            </p:extLst>
          </p:nvPr>
        </p:nvGraphicFramePr>
        <p:xfrm>
          <a:off x="1812104" y="3086101"/>
          <a:ext cx="1776037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19" name="Prism 6" r:id="rId22" imgW="4043244" imgH="3122536" progId="Prism6.Document">
                  <p:embed/>
                </p:oleObj>
              </mc:Choice>
              <mc:Fallback>
                <p:oleObj name="Prism 6" r:id="rId22" imgW="4043244" imgH="312253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812104" y="3086101"/>
                        <a:ext cx="1776037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4506511"/>
              </p:ext>
            </p:extLst>
          </p:nvPr>
        </p:nvGraphicFramePr>
        <p:xfrm>
          <a:off x="6373349" y="446547"/>
          <a:ext cx="168317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0" name="Prism 6" r:id="rId24" imgW="3988143" imgH="3250390" progId="Prism6.Document">
                  <p:embed/>
                </p:oleObj>
              </mc:Choice>
              <mc:Fallback>
                <p:oleObj name="Prism 6" r:id="rId24" imgW="3988143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6373349" y="446547"/>
                        <a:ext cx="168317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9455864"/>
              </p:ext>
            </p:extLst>
          </p:nvPr>
        </p:nvGraphicFramePr>
        <p:xfrm>
          <a:off x="7799642" y="448802"/>
          <a:ext cx="173243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1" name="Prism 6" r:id="rId26" imgW="4024877" imgH="3186643" progId="Prism6.Document">
                  <p:embed/>
                </p:oleObj>
              </mc:Choice>
              <mc:Fallback>
                <p:oleObj name="Prism 6" r:id="rId26" imgW="4024877" imgH="318664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7799642" y="448802"/>
                        <a:ext cx="173243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8830170"/>
              </p:ext>
            </p:extLst>
          </p:nvPr>
        </p:nvGraphicFramePr>
        <p:xfrm>
          <a:off x="9274484" y="442451"/>
          <a:ext cx="1698586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2" name="Prism 6" r:id="rId28" imgW="4024877" imgH="3250390" progId="Prism6.Document">
                  <p:embed/>
                </p:oleObj>
              </mc:Choice>
              <mc:Fallback>
                <p:oleObj name="Prism 6" r:id="rId28" imgW="4024877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9274484" y="442451"/>
                        <a:ext cx="1698586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0905333"/>
              </p:ext>
            </p:extLst>
          </p:nvPr>
        </p:nvGraphicFramePr>
        <p:xfrm>
          <a:off x="6385749" y="1783736"/>
          <a:ext cx="166374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3" name="Prism 6" r:id="rId30" imgW="3942406" imgH="3250390" progId="Prism6.Document">
                  <p:embed/>
                </p:oleObj>
              </mc:Choice>
              <mc:Fallback>
                <p:oleObj name="Prism 6" r:id="rId30" imgW="3942406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6385749" y="1783736"/>
                        <a:ext cx="166374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0811002"/>
              </p:ext>
            </p:extLst>
          </p:nvPr>
        </p:nvGraphicFramePr>
        <p:xfrm>
          <a:off x="7794881" y="1773903"/>
          <a:ext cx="1702606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4" name="Prism 6" r:id="rId32" imgW="4033880" imgH="3250390" progId="Prism6.Document">
                  <p:embed/>
                </p:oleObj>
              </mc:Choice>
              <mc:Fallback>
                <p:oleObj name="Prism 6" r:id="rId32" imgW="4033880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7794881" y="1773903"/>
                        <a:ext cx="1702606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511294"/>
              </p:ext>
            </p:extLst>
          </p:nvPr>
        </p:nvGraphicFramePr>
        <p:xfrm>
          <a:off x="9330047" y="1764070"/>
          <a:ext cx="1652352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5" name="Prism 6" r:id="rId34" imgW="3915035" imgH="3250390" progId="Prism6.Document">
                  <p:embed/>
                </p:oleObj>
              </mc:Choice>
              <mc:Fallback>
                <p:oleObj name="Prism 6" r:id="rId34" imgW="3915035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9330047" y="1764070"/>
                        <a:ext cx="1652352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9993092"/>
              </p:ext>
            </p:extLst>
          </p:nvPr>
        </p:nvGraphicFramePr>
        <p:xfrm>
          <a:off x="9243040" y="3081594"/>
          <a:ext cx="173342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6" name="Prism 6" r:id="rId36" imgW="4107348" imgH="3250390" progId="Prism6.Document">
                  <p:embed/>
                </p:oleObj>
              </mc:Choice>
              <mc:Fallback>
                <p:oleObj name="Prism 6" r:id="rId36" imgW="4107348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9243040" y="3081594"/>
                        <a:ext cx="173342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4566115"/>
              </p:ext>
            </p:extLst>
          </p:nvPr>
        </p:nvGraphicFramePr>
        <p:xfrm>
          <a:off x="7809476" y="3081597"/>
          <a:ext cx="1698586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7" name="Prism 6" r:id="rId38" imgW="4024877" imgH="3250390" progId="Prism6.Document">
                  <p:embed/>
                </p:oleObj>
              </mc:Choice>
              <mc:Fallback>
                <p:oleObj name="Prism 6" r:id="rId38" imgW="4024877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7809476" y="3081597"/>
                        <a:ext cx="1698586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0507835"/>
              </p:ext>
            </p:extLst>
          </p:nvPr>
        </p:nvGraphicFramePr>
        <p:xfrm>
          <a:off x="6354303" y="3081593"/>
          <a:ext cx="1698586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28" name="Prism 6" r:id="rId40" imgW="4024877" imgH="3250390" progId="Prism6.Document">
                  <p:embed/>
                </p:oleObj>
              </mc:Choice>
              <mc:Fallback>
                <p:oleObj name="Prism 6" r:id="rId40" imgW="4024877" imgH="325039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6354303" y="3081593"/>
                        <a:ext cx="1698586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344730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388624" y="4327077"/>
            <a:ext cx="4757634" cy="10781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4.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White adipose tissue </a:t>
            </a:r>
            <a:r>
              <a:rPr lang="en-US" sz="12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expression of genes related to the circadian clock in male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ata represent the mean ± SEM of 4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6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 per experimental group and 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ZT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*P&lt;0.05, **P&lt;0.01, ***, P&lt;0.001, as determined by two-way ANOVA and </a:t>
            </a:r>
            <a:r>
              <a:rPr lang="en-US" sz="1200" dirty="0" err="1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Tukey’s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post hoc test. 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/>
          <a:srcRect l="66266" t="13656" r="27044" b="78103"/>
          <a:stretch/>
        </p:blipFill>
        <p:spPr>
          <a:xfrm>
            <a:off x="1805339" y="159857"/>
            <a:ext cx="359898" cy="25582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5"/>
          <a:srcRect l="48734" t="-1" r="33222" b="25455"/>
          <a:stretch/>
        </p:blipFill>
        <p:spPr>
          <a:xfrm>
            <a:off x="2884442" y="191090"/>
            <a:ext cx="327804" cy="222689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2065032" y="181828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+/+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195915" y="181828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/-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5895344" y="4337237"/>
            <a:ext cx="4757634" cy="10781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5.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White adipose tissue </a:t>
            </a:r>
            <a:r>
              <a:rPr lang="en-US" sz="12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expression of genes related to the circadian clock in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female </a:t>
            </a:r>
            <a:r>
              <a:rPr lang="en-US" sz="12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. 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ata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represent the mean ± SEM of 4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6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 per experimental group and 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ZT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*P&lt;0.05, **P&lt;0.01, ***, P&lt;0.001, as determined by two-way ANOVA and </a:t>
            </a:r>
            <a:r>
              <a:rPr lang="en-US" sz="1200" dirty="0" err="1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Tukey’s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post hoc test. </a:t>
            </a: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4"/>
          <a:srcRect l="66266" t="13656" r="27044" b="78103"/>
          <a:stretch/>
        </p:blipFill>
        <p:spPr>
          <a:xfrm>
            <a:off x="7312059" y="170017"/>
            <a:ext cx="359898" cy="255827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5"/>
          <a:srcRect l="48734" t="-1" r="33222" b="25455"/>
          <a:stretch/>
        </p:blipFill>
        <p:spPr>
          <a:xfrm>
            <a:off x="8391162" y="201250"/>
            <a:ext cx="327804" cy="222689"/>
          </a:xfrm>
          <a:prstGeom prst="rect">
            <a:avLst/>
          </a:prstGeom>
        </p:spPr>
      </p:pic>
      <p:sp>
        <p:nvSpPr>
          <p:cNvPr id="28" name="Rectangle 27"/>
          <p:cNvSpPr/>
          <p:nvPr/>
        </p:nvSpPr>
        <p:spPr>
          <a:xfrm>
            <a:off x="7571752" y="191988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+/+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8702635" y="191988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/-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366548"/>
              </p:ext>
            </p:extLst>
          </p:nvPr>
        </p:nvGraphicFramePr>
        <p:xfrm>
          <a:off x="5808458" y="443474"/>
          <a:ext cx="180080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89" name="Prism 6" r:id="rId6" imgW="4015873" imgH="3058428" progId="Prism6.Document">
                  <p:embed/>
                </p:oleObj>
              </mc:Choice>
              <mc:Fallback>
                <p:oleObj name="Prism 6" r:id="rId6" imgW="4015873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808458" y="443474"/>
                        <a:ext cx="180080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3138892"/>
              </p:ext>
            </p:extLst>
          </p:nvPr>
        </p:nvGraphicFramePr>
        <p:xfrm>
          <a:off x="7371787" y="453306"/>
          <a:ext cx="180080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0" name="Prism 6" r:id="rId8" imgW="4015873" imgH="3058428" progId="Prism6.Document">
                  <p:embed/>
                </p:oleObj>
              </mc:Choice>
              <mc:Fallback>
                <p:oleObj name="Prism 6" r:id="rId8" imgW="4015873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371787" y="453306"/>
                        <a:ext cx="180080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3547844"/>
              </p:ext>
            </p:extLst>
          </p:nvPr>
        </p:nvGraphicFramePr>
        <p:xfrm>
          <a:off x="8926191" y="443475"/>
          <a:ext cx="180080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1" name="Prism 6" r:id="rId10" imgW="4015873" imgH="3058428" progId="Prism6.Document">
                  <p:embed/>
                </p:oleObj>
              </mc:Choice>
              <mc:Fallback>
                <p:oleObj name="Prism 6" r:id="rId10" imgW="4015873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926191" y="443475"/>
                        <a:ext cx="180080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3851512"/>
              </p:ext>
            </p:extLst>
          </p:nvPr>
        </p:nvGraphicFramePr>
        <p:xfrm>
          <a:off x="5849424" y="1770831"/>
          <a:ext cx="175524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2" name="Prism 6" r:id="rId12" imgW="3915035" imgH="3058428" progId="Prism6.Document">
                  <p:embed/>
                </p:oleObj>
              </mc:Choice>
              <mc:Fallback>
                <p:oleObj name="Prism 6" r:id="rId12" imgW="3915035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849424" y="1770831"/>
                        <a:ext cx="175524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3320624"/>
              </p:ext>
            </p:extLst>
          </p:nvPr>
        </p:nvGraphicFramePr>
        <p:xfrm>
          <a:off x="7371788" y="1780666"/>
          <a:ext cx="180080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3" name="Prism 6" r:id="rId14" imgW="4015873" imgH="3058428" progId="Prism6.Document">
                  <p:embed/>
                </p:oleObj>
              </mc:Choice>
              <mc:Fallback>
                <p:oleObj name="Prism 6" r:id="rId14" imgW="4015873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371788" y="1780666"/>
                        <a:ext cx="180080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5717016"/>
              </p:ext>
            </p:extLst>
          </p:nvPr>
        </p:nvGraphicFramePr>
        <p:xfrm>
          <a:off x="8976084" y="1780666"/>
          <a:ext cx="175524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4" name="Prism 6" r:id="rId16" imgW="3915035" imgH="3058428" progId="Prism6.Document">
                  <p:embed/>
                </p:oleObj>
              </mc:Choice>
              <mc:Fallback>
                <p:oleObj name="Prism 6" r:id="rId16" imgW="3915035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8976084" y="1780666"/>
                        <a:ext cx="175524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6096130"/>
              </p:ext>
            </p:extLst>
          </p:nvPr>
        </p:nvGraphicFramePr>
        <p:xfrm>
          <a:off x="5849426" y="3078517"/>
          <a:ext cx="175524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5" name="Prism 6" r:id="rId18" imgW="3915035" imgH="3058428" progId="Prism6.Document">
                  <p:embed/>
                </p:oleObj>
              </mc:Choice>
              <mc:Fallback>
                <p:oleObj name="Prism 6" r:id="rId18" imgW="3915035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849426" y="3078517"/>
                        <a:ext cx="175524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9611308"/>
              </p:ext>
            </p:extLst>
          </p:nvPr>
        </p:nvGraphicFramePr>
        <p:xfrm>
          <a:off x="7422587" y="3071299"/>
          <a:ext cx="175524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6" name="Prism 6" r:id="rId20" imgW="3915035" imgH="3058428" progId="Prism6.Document">
                  <p:embed/>
                </p:oleObj>
              </mc:Choice>
              <mc:Fallback>
                <p:oleObj name="Prism 6" r:id="rId20" imgW="3915035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7422587" y="3071299"/>
                        <a:ext cx="175524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9847516"/>
              </p:ext>
            </p:extLst>
          </p:nvPr>
        </p:nvGraphicFramePr>
        <p:xfrm>
          <a:off x="8925283" y="3068687"/>
          <a:ext cx="180080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7" name="Prism 6" r:id="rId22" imgW="4015873" imgH="3058428" progId="Prism6.Document">
                  <p:embed/>
                </p:oleObj>
              </mc:Choice>
              <mc:Fallback>
                <p:oleObj name="Prism 6" r:id="rId22" imgW="4015873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8925283" y="3068687"/>
                        <a:ext cx="180080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7545267"/>
              </p:ext>
            </p:extLst>
          </p:nvPr>
        </p:nvGraphicFramePr>
        <p:xfrm>
          <a:off x="275713" y="462012"/>
          <a:ext cx="187340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8" name="Prism 6" r:id="rId24" imgW="4088981" imgH="2994321" progId="Prism6.Document">
                  <p:embed/>
                </p:oleObj>
              </mc:Choice>
              <mc:Fallback>
                <p:oleObj name="Prism 6" r:id="rId24" imgW="4088981" imgH="299432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75713" y="462012"/>
                        <a:ext cx="187340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0696078"/>
              </p:ext>
            </p:extLst>
          </p:nvPr>
        </p:nvGraphicFramePr>
        <p:xfrm>
          <a:off x="1878370" y="453306"/>
          <a:ext cx="183354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99" name="Prism 6" r:id="rId26" imgW="4088981" imgH="3058428" progId="Prism6.Document">
                  <p:embed/>
                </p:oleObj>
              </mc:Choice>
              <mc:Fallback>
                <p:oleObj name="Prism 6" r:id="rId26" imgW="4088981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878370" y="453306"/>
                        <a:ext cx="183354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2757596"/>
              </p:ext>
            </p:extLst>
          </p:nvPr>
        </p:nvGraphicFramePr>
        <p:xfrm>
          <a:off x="3441700" y="453310"/>
          <a:ext cx="183354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00" name="Prism 6" r:id="rId28" imgW="4088981" imgH="3058428" progId="Prism6.Document">
                  <p:embed/>
                </p:oleObj>
              </mc:Choice>
              <mc:Fallback>
                <p:oleObj name="Prism 6" r:id="rId28" imgW="4088981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441700" y="453310"/>
                        <a:ext cx="183354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834409"/>
              </p:ext>
            </p:extLst>
          </p:nvPr>
        </p:nvGraphicFramePr>
        <p:xfrm>
          <a:off x="353193" y="1721669"/>
          <a:ext cx="175524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01" name="Prism 6" r:id="rId30" imgW="3915035" imgH="3058428" progId="Prism6.Document">
                  <p:embed/>
                </p:oleObj>
              </mc:Choice>
              <mc:Fallback>
                <p:oleObj name="Prism 6" r:id="rId30" imgW="3915035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353193" y="1721669"/>
                        <a:ext cx="175524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1700015"/>
              </p:ext>
            </p:extLst>
          </p:nvPr>
        </p:nvGraphicFramePr>
        <p:xfrm>
          <a:off x="1936190" y="1721669"/>
          <a:ext cx="1755249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02" name="Prism 6" r:id="rId32" imgW="3915035" imgH="3058428" progId="Prism6.Document">
                  <p:embed/>
                </p:oleObj>
              </mc:Choice>
              <mc:Fallback>
                <p:oleObj name="Prism 6" r:id="rId32" imgW="3915035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1936190" y="1721669"/>
                        <a:ext cx="1755249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400786"/>
              </p:ext>
            </p:extLst>
          </p:nvPr>
        </p:nvGraphicFramePr>
        <p:xfrm>
          <a:off x="3504893" y="1721670"/>
          <a:ext cx="1767350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03" name="Prism 6" r:id="rId34" imgW="3942406" imgH="3058428" progId="Prism6.Document">
                  <p:embed/>
                </p:oleObj>
              </mc:Choice>
              <mc:Fallback>
                <p:oleObj name="Prism 6" r:id="rId34" imgW="3942406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3504893" y="1721670"/>
                        <a:ext cx="1767350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9353752"/>
              </p:ext>
            </p:extLst>
          </p:nvPr>
        </p:nvGraphicFramePr>
        <p:xfrm>
          <a:off x="358264" y="2990030"/>
          <a:ext cx="1759520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04" name="Prism 6" r:id="rId36" imgW="3924399" imgH="3058428" progId="Prism6.Document">
                  <p:embed/>
                </p:oleObj>
              </mc:Choice>
              <mc:Fallback>
                <p:oleObj name="Prism 6" r:id="rId36" imgW="3924399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358264" y="2990030"/>
                        <a:ext cx="1759520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9927532"/>
              </p:ext>
            </p:extLst>
          </p:nvPr>
        </p:nvGraphicFramePr>
        <p:xfrm>
          <a:off x="1871097" y="2992640"/>
          <a:ext cx="1812904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05" name="Prism 6" r:id="rId38" imgW="4043244" imgH="3058428" progId="Prism6.Document">
                  <p:embed/>
                </p:oleObj>
              </mc:Choice>
              <mc:Fallback>
                <p:oleObj name="Prism 6" r:id="rId38" imgW="4043244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1871097" y="2992640"/>
                        <a:ext cx="1812904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4362391"/>
              </p:ext>
            </p:extLst>
          </p:nvPr>
        </p:nvGraphicFramePr>
        <p:xfrm>
          <a:off x="3458550" y="2990033"/>
          <a:ext cx="1800803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06" name="Prism 6" r:id="rId40" imgW="4015873" imgH="3058428" progId="Prism6.Document">
                  <p:embed/>
                </p:oleObj>
              </mc:Choice>
              <mc:Fallback>
                <p:oleObj name="Prism 6" r:id="rId40" imgW="4015873" imgH="305842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3458550" y="2990033"/>
                        <a:ext cx="1800803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17451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388624" y="4415421"/>
            <a:ext cx="4757634" cy="10781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6.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Expression </a:t>
            </a:r>
            <a:r>
              <a:rPr lang="en-US" sz="12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of genes related to the circadian clock in male </a:t>
            </a:r>
            <a:r>
              <a:rPr lang="en-US" sz="1200" b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 BAT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ata represent the mean ± SEM of 4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6 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mice per experimental group and </a:t>
            </a:r>
            <a:r>
              <a:rPr lang="en-US" sz="12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ZT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*P&lt;0.05, **P&lt;0.01, ***, P&lt;0.001, as determined by two-way ANOVA and </a:t>
            </a:r>
            <a:r>
              <a:rPr lang="en-US" sz="1200" dirty="0" err="1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Tukey’s</a:t>
            </a:r>
            <a:r>
              <a:rPr lang="en-US" sz="12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post hoc test. 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/>
          <a:srcRect l="66266" t="13656" r="27044" b="78103"/>
          <a:stretch/>
        </p:blipFill>
        <p:spPr>
          <a:xfrm>
            <a:off x="1805339" y="314459"/>
            <a:ext cx="359898" cy="25582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5"/>
          <a:srcRect l="48734" t="-1" r="33222" b="25455"/>
          <a:stretch/>
        </p:blipFill>
        <p:spPr>
          <a:xfrm>
            <a:off x="2884442" y="345692"/>
            <a:ext cx="327804" cy="222689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2065032" y="336430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+/+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195915" y="336430"/>
            <a:ext cx="826545" cy="255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i="1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Dio3</a:t>
            </a:r>
            <a:r>
              <a:rPr lang="en-US" sz="1200" i="1" baseline="30000" dirty="0" smtClean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-/-</a:t>
            </a:r>
            <a:endParaRPr lang="en-US" sz="1200" i="1" baseline="30000" dirty="0">
              <a:latin typeface="Arial" panose="020B0604020202020204" pitchFamily="34" charset="0"/>
              <a:ea typeface="DengXian"/>
              <a:cs typeface="Arial" panose="020B0604020202020204" pitchFamily="34" charset="0"/>
            </a:endParaRPr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9871582"/>
              </p:ext>
            </p:extLst>
          </p:nvPr>
        </p:nvGraphicFramePr>
        <p:xfrm>
          <a:off x="310896" y="566928"/>
          <a:ext cx="177981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1" name="Prism 6" r:id="rId6" imgW="3979140" imgH="3067432" progId="Prism6.Document">
                  <p:embed/>
                </p:oleObj>
              </mc:Choice>
              <mc:Fallback>
                <p:oleObj name="Prism 6" r:id="rId6" imgW="3979140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0896" y="566928"/>
                        <a:ext cx="177981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5924407"/>
              </p:ext>
            </p:extLst>
          </p:nvPr>
        </p:nvGraphicFramePr>
        <p:xfrm>
          <a:off x="1925055" y="566928"/>
          <a:ext cx="1750707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2" name="Prism 6" r:id="rId8" imgW="3915035" imgH="3067432" progId="Prism6.Document">
                  <p:embed/>
                </p:oleObj>
              </mc:Choice>
              <mc:Fallback>
                <p:oleObj name="Prism 6" r:id="rId8" imgW="3915035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925055" y="566928"/>
                        <a:ext cx="1750707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3604807"/>
              </p:ext>
            </p:extLst>
          </p:nvPr>
        </p:nvGraphicFramePr>
        <p:xfrm>
          <a:off x="3503232" y="566928"/>
          <a:ext cx="1750707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3" name="Prism 6" r:id="rId10" imgW="3915035" imgH="3067432" progId="Prism6.Document">
                  <p:embed/>
                </p:oleObj>
              </mc:Choice>
              <mc:Fallback>
                <p:oleObj name="Prism 6" r:id="rId10" imgW="3915035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03232" y="566928"/>
                        <a:ext cx="1750707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4660013"/>
              </p:ext>
            </p:extLst>
          </p:nvPr>
        </p:nvGraphicFramePr>
        <p:xfrm>
          <a:off x="310896" y="1834895"/>
          <a:ext cx="1816021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4" name="Prism 6" r:id="rId12" imgW="4061611" imgH="3067432" progId="Prism6.Document">
                  <p:embed/>
                </p:oleObj>
              </mc:Choice>
              <mc:Fallback>
                <p:oleObj name="Prism 6" r:id="rId12" imgW="4061611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10896" y="1834895"/>
                        <a:ext cx="1816021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5657170"/>
              </p:ext>
            </p:extLst>
          </p:nvPr>
        </p:nvGraphicFramePr>
        <p:xfrm>
          <a:off x="1853331" y="1827315"/>
          <a:ext cx="1854415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5" name="Prism 6" r:id="rId14" imgW="4061611" imgH="3003685" progId="Prism6.Document">
                  <p:embed/>
                </p:oleObj>
              </mc:Choice>
              <mc:Fallback>
                <p:oleObj name="Prism 6" r:id="rId14" imgW="4061611" imgH="300368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853331" y="1827315"/>
                        <a:ext cx="1854415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0099425"/>
              </p:ext>
            </p:extLst>
          </p:nvPr>
        </p:nvGraphicFramePr>
        <p:xfrm>
          <a:off x="3441187" y="1805397"/>
          <a:ext cx="1816021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6" name="Prism 6" r:id="rId16" imgW="4061611" imgH="3067432" progId="Prism6.Document">
                  <p:embed/>
                </p:oleObj>
              </mc:Choice>
              <mc:Fallback>
                <p:oleObj name="Prism 6" r:id="rId16" imgW="4061611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441187" y="1805397"/>
                        <a:ext cx="1816021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40707"/>
              </p:ext>
            </p:extLst>
          </p:nvPr>
        </p:nvGraphicFramePr>
        <p:xfrm>
          <a:off x="307769" y="3103258"/>
          <a:ext cx="1808212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7" name="Prism 6" r:id="rId18" imgW="4043244" imgH="3067432" progId="Prism6.Document">
                  <p:embed/>
                </p:oleObj>
              </mc:Choice>
              <mc:Fallback>
                <p:oleObj name="Prism 6" r:id="rId18" imgW="4043244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07769" y="3103258"/>
                        <a:ext cx="1808212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0888493"/>
              </p:ext>
            </p:extLst>
          </p:nvPr>
        </p:nvGraphicFramePr>
        <p:xfrm>
          <a:off x="1843500" y="3093426"/>
          <a:ext cx="1816021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8" name="Prism 6" r:id="rId20" imgW="4061611" imgH="3067432" progId="Prism6.Document">
                  <p:embed/>
                </p:oleObj>
              </mc:Choice>
              <mc:Fallback>
                <p:oleObj name="Prism 6" r:id="rId20" imgW="4061611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843500" y="3093426"/>
                        <a:ext cx="1816021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5368226"/>
              </p:ext>
            </p:extLst>
          </p:nvPr>
        </p:nvGraphicFramePr>
        <p:xfrm>
          <a:off x="3446156" y="3093426"/>
          <a:ext cx="1816021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69" name="Prism 6" r:id="rId22" imgW="4061611" imgH="3067432" progId="Prism6.Document">
                  <p:embed/>
                </p:oleObj>
              </mc:Choice>
              <mc:Fallback>
                <p:oleObj name="Prism 6" r:id="rId22" imgW="4061611" imgH="306743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446156" y="3093426"/>
                        <a:ext cx="1816021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5477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9</TotalTime>
  <Words>402</Words>
  <Application>Microsoft Office PowerPoint</Application>
  <PresentationFormat>Widescreen</PresentationFormat>
  <Paragraphs>26</Paragraphs>
  <Slides>4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DengXian</vt:lpstr>
      <vt:lpstr>Arial</vt:lpstr>
      <vt:lpstr>Calibri</vt:lpstr>
      <vt:lpstr>Calibri Light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</vt:vector>
  </TitlesOfParts>
  <Company>Maine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Zhaofei</dc:creator>
  <cp:lastModifiedBy>Zhaofei Wu</cp:lastModifiedBy>
  <cp:revision>60</cp:revision>
  <cp:lastPrinted>2024-02-07T14:46:11Z</cp:lastPrinted>
  <dcterms:created xsi:type="dcterms:W3CDTF">2022-10-12T16:34:32Z</dcterms:created>
  <dcterms:modified xsi:type="dcterms:W3CDTF">2024-02-22T15:20:54Z</dcterms:modified>
</cp:coreProperties>
</file>